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5" r:id="rId2"/>
    <p:sldId id="260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64"/>
    <p:restoredTop sz="96405"/>
  </p:normalViewPr>
  <p:slideViewPr>
    <p:cSldViewPr snapToGrid="0">
      <p:cViewPr varScale="1">
        <p:scale>
          <a:sx n="93" d="100"/>
          <a:sy n="93" d="100"/>
        </p:scale>
        <p:origin x="20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239772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052691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861126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30322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80440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941750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976699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588588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599336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090220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869366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7F5BD-A99D-FE43-BB01-E40D78B72E60}" type="datetimeFigureOut">
              <a:rPr lang="en-CN" smtClean="0"/>
              <a:t>2023/4/3</a:t>
            </a:fld>
            <a:endParaRPr lang="en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56F9AD-4730-CD47-A6E5-1B59CF994EC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597320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745E65D-90D5-5AA5-AB39-2811D6AD769D}"/>
              </a:ext>
            </a:extLst>
          </p:cNvPr>
          <p:cNvSpPr txBox="1"/>
          <p:nvPr/>
        </p:nvSpPr>
        <p:spPr>
          <a:xfrm>
            <a:off x="249044" y="128467"/>
            <a:ext cx="2044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sp>
        <p:nvSpPr>
          <p:cNvPr id="34" name="Rectangle 134">
            <a:extLst>
              <a:ext uri="{FF2B5EF4-FFF2-40B4-BE49-F238E27FC236}">
                <a16:creationId xmlns:a16="http://schemas.microsoft.com/office/drawing/2014/main" id="{15FE7F2D-DD40-249F-F3C5-DE44594FB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9248" y="990865"/>
            <a:ext cx="3610745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2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posed experiments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2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a cell free apoptosis system</a:t>
            </a:r>
          </a:p>
        </p:txBody>
      </p:sp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2A2D16DD-3D1F-7B0F-35DA-D4F729CBEF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6115328"/>
              </p:ext>
            </p:extLst>
          </p:nvPr>
        </p:nvGraphicFramePr>
        <p:xfrm>
          <a:off x="471129" y="1809910"/>
          <a:ext cx="5919605" cy="186209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631129">
                  <a:extLst>
                    <a:ext uri="{9D8B030D-6E8A-4147-A177-3AD203B41FA5}">
                      <a16:colId xmlns:a16="http://schemas.microsoft.com/office/drawing/2014/main" val="406134511"/>
                    </a:ext>
                  </a:extLst>
                </a:gridCol>
                <a:gridCol w="1644238">
                  <a:extLst>
                    <a:ext uri="{9D8B030D-6E8A-4147-A177-3AD203B41FA5}">
                      <a16:colId xmlns:a16="http://schemas.microsoft.com/office/drawing/2014/main" val="1456089792"/>
                    </a:ext>
                  </a:extLst>
                </a:gridCol>
                <a:gridCol w="1644238">
                  <a:extLst>
                    <a:ext uri="{9D8B030D-6E8A-4147-A177-3AD203B41FA5}">
                      <a16:colId xmlns:a16="http://schemas.microsoft.com/office/drawing/2014/main" val="1889101177"/>
                    </a:ext>
                  </a:extLst>
                </a:gridCol>
              </a:tblGrid>
              <a:tr h="855316">
                <a:tc>
                  <a:txBody>
                    <a:bodyPr/>
                    <a:lstStyle/>
                    <a:p>
                      <a:pPr algn="ctr"/>
                      <a:endParaRPr lang="en-CN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incubate C3 with Cyt </a:t>
                      </a:r>
                      <a:r>
                        <a:rPr lang="en-CN" sz="16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incubate C3 with cytosol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78702641"/>
                  </a:ext>
                </a:extLst>
              </a:tr>
              <a:tr h="427658"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 binds Cyt </a:t>
                      </a:r>
                      <a:r>
                        <a:rPr lang="en-CN" sz="16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apoptosis</a:t>
                      </a:r>
                    </a:p>
                  </a:txBody>
                  <a:tcPr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</a:t>
                      </a:r>
                    </a:p>
                  </a:txBody>
                  <a:tcPr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767280"/>
                  </a:ext>
                </a:extLst>
              </a:tr>
              <a:tr h="550862"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 binds factors downstream of Cyt </a:t>
                      </a:r>
                      <a:r>
                        <a:rPr lang="en-CN" sz="16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</a:t>
                      </a:r>
                    </a:p>
                  </a:txBody>
                  <a:tcPr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apoptosis</a:t>
                      </a:r>
                    </a:p>
                  </a:txBody>
                  <a:tcPr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582022"/>
                  </a:ext>
                </a:extLst>
              </a:tr>
            </a:tbl>
          </a:graphicData>
        </a:graphic>
      </p:graphicFrame>
      <p:sp>
        <p:nvSpPr>
          <p:cNvPr id="5" name="Rectangle 134">
            <a:extLst>
              <a:ext uri="{FF2B5EF4-FFF2-40B4-BE49-F238E27FC236}">
                <a16:creationId xmlns:a16="http://schemas.microsoft.com/office/drawing/2014/main" id="{285B0554-9A4B-E886-1082-57693C9243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0960" y="2036092"/>
            <a:ext cx="151177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pothes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718558A-BF7D-A9FF-FE79-D53D909E3D21}"/>
              </a:ext>
            </a:extLst>
          </p:cNvPr>
          <p:cNvSpPr txBox="1"/>
          <p:nvPr/>
        </p:nvSpPr>
        <p:spPr>
          <a:xfrm>
            <a:off x="471129" y="4045665"/>
            <a:ext cx="569751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1.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chematic diagram depicting the hypothesis and model of the possibilities/results for C3 interaction with factor(s) in the intrinsic apoptotic pathway. </a:t>
            </a:r>
            <a:endParaRPr lang="en-CN" sz="1200" b="1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5324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4AFDAF9-423A-C243-8253-A32D627B50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66" r="5555" b="8029"/>
          <a:stretch/>
        </p:blipFill>
        <p:spPr>
          <a:xfrm>
            <a:off x="1610434" y="823816"/>
            <a:ext cx="4333739" cy="31215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F0DA0A9-3A0A-2461-3D67-E8696EC4615B}"/>
              </a:ext>
            </a:extLst>
          </p:cNvPr>
          <p:cNvSpPr txBox="1"/>
          <p:nvPr/>
        </p:nvSpPr>
        <p:spPr>
          <a:xfrm>
            <a:off x="249044" y="128467"/>
            <a:ext cx="2044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C9EEADC-CB02-62E4-9D07-BAC107AD70B2}"/>
              </a:ext>
            </a:extLst>
          </p:cNvPr>
          <p:cNvSpPr txBox="1"/>
          <p:nvPr/>
        </p:nvSpPr>
        <p:spPr>
          <a:xfrm>
            <a:off x="690470" y="4225774"/>
            <a:ext cx="569751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2. pcDNA3.1</a:t>
            </a:r>
            <a:r>
              <a:rPr lang="en-US" sz="12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C-(K)DYK vector map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full-length human C3 expressing clones are constructed using the pcDNA3.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C-(K)DYK vector. Target ORF, which is full-length C3 in this study, is cloned into pcDNA3.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C-(K)DYK vector without introducing any extra nucleotides before or after target ORF. ORFs cloned in pcDNA3.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C-(K)DYK vector were expressed in mammalian cells as a tagged protein with a C-terminal FLAG tag. Proteins expressed from this clone were detected and purified following transgene expression using anti-FLAG antibodies. </a:t>
            </a:r>
            <a:endParaRPr lang="en-CN" sz="12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dirty="0">
              <a:effectLst/>
              <a:latin typeface="Arial" panose="020B060402020202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2097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244</TotalTime>
  <Words>181</Words>
  <Application>Microsoft Macintosh PowerPoint</Application>
  <PresentationFormat>On-screen Show (4:3)</PresentationFormat>
  <Paragraphs>1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 Fang</dc:creator>
  <cp:lastModifiedBy>zhou fang</cp:lastModifiedBy>
  <cp:revision>134</cp:revision>
  <dcterms:created xsi:type="dcterms:W3CDTF">2023-01-24T18:15:10Z</dcterms:created>
  <dcterms:modified xsi:type="dcterms:W3CDTF">2023-04-03T18:47:06Z</dcterms:modified>
</cp:coreProperties>
</file>